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0" d="100"/>
          <a:sy n="120" d="100"/>
        </p:scale>
        <p:origin x="20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692CE3-2EBF-83CC-BD6E-A04E971981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4BFE2C-1A1C-FF17-F9BE-863973D6AF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5D2AB2-1DF7-736A-1064-32819D7A8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1C20CC-B631-D547-D66E-51100CEE3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A6AC94-2CCB-6B3D-982A-BCE9C34EB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150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A8B984-C649-962D-3FCF-12480DBF66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24E7D7-E3D4-CFAD-02A4-F9C72581DC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4C0775-CE24-EA91-593B-D4D356FFF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92B911-8788-F8A1-E2B9-176383382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9A7C69-9AA2-D31B-6420-C7E9A050F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529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0EACCB-7955-38D5-74C3-435A312FCB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AC6B52-DDF3-2F2F-1B62-88B847859D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659DA-B458-FF2F-3A83-EB655A2AD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325BB6-D84E-5751-766E-1312B8F16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CF7322-55C7-A506-6737-7996F3AE59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72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DDAB0B-697F-844D-F071-D85A453541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299CC5-7DC3-EF62-9B48-B4CC58515E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550906-F337-686E-6D5C-E3299B50FC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2F4B47-0C9C-FC4B-B9B7-68883A0D7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9DB3A5-1468-C9F1-54F3-0A7DADF5EC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297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8F462C-3345-8D01-8F1E-F3881A8E65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78E425-39C5-7F9E-020C-89A5C1309D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4A3E45-CE21-86B5-847D-3FEEB1AE5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5AC1A9-2C0A-BF88-56AF-A356816C4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E079AD-D523-2D9F-7DFB-AB7D4F7E3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624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8EB6FE-D8BB-E2B2-967F-29516BAAFE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8195A8-F888-FBF7-C7CA-3CF186A976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0B66FC-ED3E-894F-FD50-D6D26B51FC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341509-7020-AB25-A06F-9DDD78B46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0A15F5-0DCC-2B5A-779C-AF781B203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8844D-0616-332F-9016-7F27FBA04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895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66BD1-4383-38D0-87CC-122FD582E5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97CDE0-B163-BB74-C7A5-02EAEAA682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7509B7-A0B8-B111-849A-7443902F34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BFB38DA-D7FB-9DE6-B8F0-E5DB83BFA2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A39908-0137-0872-FD7B-89889D6817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AA0E79C-37A7-15E5-F2CB-68E43409A1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E9D1386-C0B1-2644-920B-035FEE094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866450-CB84-8CC8-746F-73F095088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718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79F69-58D4-1693-36BF-673C4AB6AF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3F3E6A4-B7D9-0EC4-7450-1257EBCBA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7D7DBE-3F43-0744-C858-AE1735493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1708258-6905-7A99-D00B-4FF645175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335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540E68-FCE3-E816-5F38-7B9C94275D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9754AB4-5B7A-E74A-C280-7D0F0FB2E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A810A2B-8E69-3289-960F-373D929002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973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246E02-3A80-29DB-625D-242C022667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DBCE94-DB71-FFCF-C8E1-6965DCC0E9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605E9C-600F-32A4-71B1-9BD1807B77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913E4A-1BF7-EFA9-1314-75D4A4857D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851F25-3256-8C05-96BF-75F660277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17C13D-9051-9212-A9A8-7FAA93BCE7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785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81C4E6-C644-7127-B133-6DABDDA4AA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216EE6C-B006-78ED-3C4F-6366EC941A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B8A737-C204-8B7F-A4EE-ED0F63C919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EC3C7A-0F3F-8301-A786-92BBF6C01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0A0AB4-E46E-01EC-C4F3-BE71F84B9E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77520B-CC35-807C-9FBC-A941A19F7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888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F661459-3CCE-6299-EDF7-3F29B92DE8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AF3AEF-7341-7450-AB73-A04AAA85C7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056753-F285-E065-FB24-DD7712F1AF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6FAD19-1D07-EF4E-869F-B281B824F545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408031-72E4-00C6-17D6-6C0B03FCB5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35BC5C-A32F-4A3E-2980-E766D21CB6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2909C1-4A48-0944-B9B5-1790888D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499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ABEB05B-B360-698C-B7E8-776BA2A2C1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3861" y="468430"/>
            <a:ext cx="10744277" cy="428492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BEF696D-CE0E-F027-3A2E-D47EB0D4644A}"/>
              </a:ext>
            </a:extLst>
          </p:cNvPr>
          <p:cNvSpPr txBox="1"/>
          <p:nvPr/>
        </p:nvSpPr>
        <p:spPr>
          <a:xfrm>
            <a:off x="0" y="4753350"/>
            <a:ext cx="12193773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 fontAlgn="base"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Figure S6: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Gating strategy for quantifying OPA and 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 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3a LPS gel.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 (A) Cells are gated first by size, then by CD45+ APC- (live) populations. An unrelated, nonbinding 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mAb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 negative control is used to set the %CTV+ gate. (B) SDS-PAGE of crude LPS extract from 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 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3a, 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 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3a 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waaL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::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kan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 (O-Ag-), and complemented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3a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waaL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::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kan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pwaaL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confirms that knocking out 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waaL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 eliminates O-Ag expression. The gel was stained with Pro-Q Emerald 3000 for visualization of O-Ag banding.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174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0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yden Schmidt</dc:creator>
  <cp:lastModifiedBy>Hayden Schmidt</cp:lastModifiedBy>
  <cp:revision>1</cp:revision>
  <dcterms:created xsi:type="dcterms:W3CDTF">2026-02-19T23:46:27Z</dcterms:created>
  <dcterms:modified xsi:type="dcterms:W3CDTF">2026-02-19T23:46:38Z</dcterms:modified>
</cp:coreProperties>
</file>